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992" y="-6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664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569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386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967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138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638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463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261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103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828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248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8933ED-0A10-42AE-A228-6413AA2F31A2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BD173-A8CF-4878-9E40-5497391B00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14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4">
            <a:extLst>
              <a:ext uri="{FF2B5EF4-FFF2-40B4-BE49-F238E27FC236}">
                <a16:creationId xmlns:a16="http://schemas.microsoft.com/office/drawing/2014/main" xmlns="" id="{0376421F-F1F9-4F9E-99D1-34C40E45BF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2856066"/>
              </p:ext>
            </p:extLst>
          </p:nvPr>
        </p:nvGraphicFramePr>
        <p:xfrm>
          <a:off x="914400" y="491786"/>
          <a:ext cx="8128000" cy="250698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256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3684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07737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062579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</a:tblGrid>
              <a:tr h="215213"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 b="1" i="0" dirty="0"/>
                        <a:t>Metabolic pathway</a:t>
                      </a:r>
                      <a:endParaRPr b="1" i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 b="1" i="0" dirty="0"/>
                        <a:t>Gene name</a:t>
                      </a:r>
                      <a:endParaRPr b="1" i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 b="1" i="0" dirty="0"/>
                        <a:t>Forward primer (5’-3’)</a:t>
                      </a:r>
                      <a:endParaRPr b="1" i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fr-FR" sz="1100" b="1" i="0" dirty="0"/>
                        <a:t>Reverse primer (5’-3’)</a:t>
                      </a:r>
                      <a:endParaRPr lang="en-US" sz="1100" b="1" i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GB" sz="1100" b="1" i="0" dirty="0"/>
                        <a:t>Accession number (Genoscope. GenBank, NCBI)/reference</a:t>
                      </a:r>
                      <a:endParaRPr lang="en-US" sz="1100" b="1" i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/>
                        <a:t>Glucose transporter</a:t>
                      </a:r>
                      <a:endParaRPr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 i="1"/>
                        <a:t>glut2a</a:t>
                      </a:r>
                      <a:endParaRPr i="1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/>
                        <a:t>GACAGGCACTCTAACCCTAG</a:t>
                      </a:r>
                      <a:endParaRPr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/>
                        <a:t>CTTCCTGCGTCTCTGTACTG</a:t>
                      </a:r>
                      <a:endParaRPr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/>
                        <a:t>GSONMG00024093001</a:t>
                      </a:r>
                      <a:endParaRPr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defRPr/>
                      </a:pPr>
                      <a:endParaRPr lang="en-US" sz="110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 i="1"/>
                        <a:t>glut2b </a:t>
                      </a:r>
                      <a:endParaRPr i="1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/>
                        <a:t>CTATCAGAGAACGGTACAGGG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/>
                        <a:t>CAGGAAGGATGACACCACG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defRPr/>
                      </a:pPr>
                      <a:r>
                        <a:rPr lang="en-US" sz="1100"/>
                        <a:t>GSONMG00057853001</a:t>
                      </a:r>
                      <a:endParaRPr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Glycolysis 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/>
                        <a:t>gcka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TGCCCACCTACGTCTGT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GTCATGGCGTCCTCAGAGAT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GSONMG00033781001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/>
                        <a:t>gckb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TCTGTGCTAGAGACAGCCC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ATTTTGACGCTGGACTCCT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GSONMG00012878001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/>
                        <a:t>pfkla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ATCCCTGCCACCATCAGTA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TAACCACAGTAGCCTCCCA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SONMG00009459001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/>
                        <a:t>pfklb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AGTGCTCGCTGTAAGGTCTT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TGATCCGGCCTTTCTGAAC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SONMG00001975001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 dirty="0"/>
                        <a:t>pk</a:t>
                      </a:r>
                      <a:endParaRPr lang="en-US" sz="1100" i="1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CATCGTCGCGGTAACAAGA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CCCCTGGCCTTTCCTATGT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ontigAF246146.s.om.10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luconeogenesis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/>
                        <a:t>pck1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ACAGGGTGAGGCAGATGTAGG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spc="-5"/>
                        <a:t>CTAGTCTGTGGAGGTCTAAGGGC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GSONMG00082468001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/>
                        <a:t>pck2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ACAATGAGATGATGTGACTGCA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TGCTCCATCACCTACAACCT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SONMG00059643001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 dirty="0"/>
                        <a:t>fbp1a</a:t>
                      </a:r>
                      <a:endParaRPr lang="en-US" sz="1100" i="1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ACAGAGGACGACCCGTG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TACTGACCGGGTCCAACAT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SONMT00001932001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/>
                        <a:t>fbp1b1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TCTCAAGAACCTCTACAGCCT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TCAGTTCTCCCGTTCCCTTC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SONMT00063051001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/>
                        <a:t>fbp1b2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ATCAGCAGGAATAGGTCGCG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CTCCTCCAGCACGAATCTC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SONMG00015701001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/>
                        <a:t>g6pca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ATGGCTTGACGTTCTCCT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AGATCCAGGAGAGTCCTCC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SONMG00076843001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 dirty="0"/>
                        <a:t>g6pcb1a</a:t>
                      </a:r>
                      <a:endParaRPr lang="en-US" sz="1100" i="1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GCAAGGTCCAAAGATCAGGG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GCCAATGTGAGATGTGATGGG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GSONMG00076841001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/>
                        <a:t>g6pcb1b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GCTACAGTGCTCTCCTTCTG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TCACCCCATAGCCCTGAAA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GSONMG00066036001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/>
                        <a:t>g6pcb2a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ATCGGACAATACACACAGAACT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AACTGATCTATAGCTGCTGCCT</a:t>
                      </a: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GSONMG00013076001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i="1" dirty="0"/>
                        <a:t>g6pcb2b</a:t>
                      </a:r>
                      <a:endParaRPr lang="en-US" sz="1100" i="1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CCTCTGCTCTTCTGACGTAG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TGTCCATGGCTGCTCTCTAG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GSONMG00014864001</a:t>
                      </a:r>
                      <a:endParaRPr lang="en-US" sz="1100" dirty="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Lipogenesis </a:t>
                      </a:r>
                      <a:r>
                        <a:rPr lang="en-US" sz="1100" i="1" dirty="0"/>
                        <a:t>de novo</a:t>
                      </a:r>
                      <a:endParaRPr i="1"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fr-FR" sz="1100" i="1"/>
                        <a:t>srebf1a</a:t>
                      </a:r>
                      <a:endParaRPr lang="en-US" sz="1100" i="1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AGTTGCTGCTGTGTGACCT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TGATGTGTTCGTGTGGGACT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u="none" strike="noStrike"/>
                        <a:t>XM_021624594.1 </a:t>
                      </a:r>
                      <a:endParaRPr/>
                    </a:p>
                  </a:txBody>
                  <a:tcPr marL="7620" marR="7620" marT="7620" marB="0"/>
                </a:tc>
                <a:extLst>
                  <a:ext uri="{0D108BD9-81ED-4DB2-BD59-A6C34878D82A}">
                    <a16:rowId xmlns:a16="http://schemas.microsoft.com/office/drawing/2014/main" xmlns="" val="100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g6pdb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TGTCACAGGGTCAACATAATGC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GCAGCAACATTGTGACAAG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66624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aclya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GTGTGAGCGTTATGAAGC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ATTTCAGCCGGCAATTCT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624819.1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/>
                        <a:t>aclyb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ACGGAAAAGTCCTGATCATC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TGTGAGTCTCTGTGCCGAAG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57697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3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/>
                        <a:t>aclyc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CCGGTTCACAAATGGGAT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CCAAGTCACCCAGAAAGCAT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75392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/>
                        <a:t>aca-</a:t>
                      </a:r>
                      <a:r>
                        <a:rPr lang="fr-FR" sz="1100" i="1" u="none" strike="noStrike" dirty="0"/>
                        <a:t>a</a:t>
                      </a:r>
                      <a:r>
                        <a:rPr lang="en-US" sz="1100" i="1" u="none" strike="noStrike" dirty="0"/>
                        <a:t>a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CAGGACCCTAAAGCACAGG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GTGAAAGAGGTGTCCAGG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623125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/>
                        <a:t>aca-</a:t>
                      </a:r>
                      <a:r>
                        <a:rPr lang="fr-FR" sz="1100" i="1" u="none" strike="noStrike" dirty="0"/>
                        <a:t>a</a:t>
                      </a:r>
                      <a:r>
                        <a:rPr lang="en-US" sz="1100" i="1" u="none" strike="noStrike" dirty="0"/>
                        <a:t>b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TCCAGTTCATGCTGCCTACC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CTTAATGTCCCGAGTGCGA 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618451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/>
                        <a:t>aca-</a:t>
                      </a:r>
                      <a:r>
                        <a:rPr lang="fr-FR" sz="1100" i="1" u="none" strike="noStrike" dirty="0"/>
                        <a:t>b</a:t>
                      </a:r>
                      <a:r>
                        <a:rPr lang="en-US" sz="1100" i="1" u="none" strike="noStrike" dirty="0"/>
                        <a:t>a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TCGCTCAGAATTCCGGGTAC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CGCGTGGTGATGGTTACAAT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605386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3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/>
                        <a:t>aca-</a:t>
                      </a:r>
                      <a:r>
                        <a:rPr lang="fr-FR" sz="1100" i="1" u="none" strike="noStrike" dirty="0"/>
                        <a:t>b</a:t>
                      </a:r>
                      <a:r>
                        <a:rPr lang="en-US" sz="1100" i="1" u="none" strike="noStrike" dirty="0"/>
                        <a:t>b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TGAACAGCTTGGTAAACAGCC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TCTCGTGCATTCTACCAGGG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620987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fasna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GCTCGTACCTTCCTGTTCC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CAACAAGGCCGTTCTTCAG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76228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fasnb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CTGCTACAACTGGAAACACGC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TCAAGGTAACGACACACCGT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81290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Fatty acids </a:t>
                      </a:r>
                      <a:r>
                        <a:rPr lang="el-GR" sz="1100"/>
                        <a:t>β-</a:t>
                      </a:r>
                      <a:r>
                        <a:rPr lang="en-US" sz="1100"/>
                        <a:t>oxidation 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hadh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TTATCATGGACGGCTGGGTT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24460" algn="l">
                        <a:spcBef>
                          <a:spcPts val="175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AGCTCGTGTTGATTCTGGG</a:t>
                      </a:r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73383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/>
                        <a:t>cpt1a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CGTTAGCAATGCCTCACAGA</a:t>
                      </a:r>
                      <a:endParaRPr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ACGGAACAGGTAGCGCTAT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607999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cpt1ba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AGCAAGCTTGAATTGAATCCCT</a:t>
                      </a:r>
                      <a:endParaRPr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CTTATGGCGCGCTTTATCCA</a:t>
                      </a:r>
                      <a:endParaRPr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NM_001171855.1 </a:t>
                      </a:r>
                      <a:endParaRPr dirty="0"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cpt1bb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GGTGTCCAGTTGCAGAAAGG</a:t>
                      </a:r>
                      <a:endParaRPr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TGACTTTGGTTTCTCACAGTGG</a:t>
                      </a:r>
                      <a:endParaRPr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NM_001124735.1 </a:t>
                      </a:r>
                      <a:endParaRPr dirty="0"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4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/>
                        <a:t>acox1a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ACATCGTTTCATAGACTGCCAG</a:t>
                      </a:r>
                      <a:endParaRPr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CTCAATCCTTTATCCTCCATCC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68071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/>
                        <a:t>acox3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CCTCCTCAGCCAACTACAC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CCTTAGCCACTCTCCTCTCG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77711.1 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 u="none" dirty="0"/>
                        <a:t>Cholesterol metabolism</a:t>
                      </a:r>
                      <a:endParaRPr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srebp2a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GACCCACACACGTTAATGCT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CTATGTGACTGTTCTGGGATC 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58053.1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srebp2b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ATAGTCAACAACGCGAACAGT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GTTGGCAGTGTGAAGATTG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625098.1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4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hmgcra</a:t>
                      </a:r>
                      <a:endParaRPr lang="en-US" sz="1100" b="0" i="1" u="none" strike="noStrike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GAGGTGATCGTAGGCACTG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GCTATGCACCGTGTGATGG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622177.1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hmgcrb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TGTTGTTTCGGCTGCATGT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CCATAACACGGGCAAAGTG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602157.1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cyp51a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TAAGAGACACTGAGCGCAAAC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TTATGAGAGCCAGCCCTATGAG 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XM_021560395.1</a:t>
                      </a:r>
                      <a:endParaRPr dirty="0"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cyp51b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CCTGGTCGATGGCTACTTCC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TGCTCTTCTGGGTGTAACCT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72174.1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dhcr7a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CTGCCAGCTTTGTGCTCT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CCCATGGCAACTAACTGCT 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85986.1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dhcr7b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GTTGGCGTTGGTCAAGTAAC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TTCATGTAACGCTGGGCTG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607019.1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dirty="0"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 err="1"/>
                        <a:t>lxr</a:t>
                      </a:r>
                      <a:r>
                        <a:rPr lang="fr-FR" sz="1100" i="1" u="none" strike="noStrike" dirty="0"/>
                        <a:t>a</a:t>
                      </a:r>
                      <a:r>
                        <a:rPr lang="en-US" sz="1100" i="1" u="none" strike="noStrike" dirty="0"/>
                        <a:t>a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GCAAGTGTGTACTCGTCAG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AAACGAACCCTTCTGCTTGTC 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NM_001159338</a:t>
                      </a:r>
                      <a:endParaRPr dirty="0"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 err="1"/>
                        <a:t>lxr</a:t>
                      </a:r>
                      <a:r>
                        <a:rPr lang="fr-FR" sz="1100" i="1" u="none" strike="noStrike" dirty="0"/>
                        <a:t>a</a:t>
                      </a:r>
                      <a:r>
                        <a:rPr lang="en-US" sz="1100" i="1" u="none" strike="noStrike" dirty="0"/>
                        <a:t>b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CAGAGTCAGGACCCCCAGAA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TTGAGGTCTTCAGCAGCGC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XM_021585769.1</a:t>
                      </a:r>
                      <a:endParaRPr dirty="0"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/>
                        <a:t>abca1a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ACGAGGTTGGAGGTATCAATG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ACCGAATCTTTCCAGAGCGT 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84015.1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5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/>
                        <a:t>abca1b</a:t>
                      </a:r>
                      <a:endParaRPr i="1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GTCCATACCGGAGGTCCCAG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CAGGGAGCATTTTCTTGCGGC </a:t>
                      </a:r>
                      <a:endParaRPr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/>
                        <a:t>XM_021561291.1</a:t>
                      </a:r>
                      <a:endParaRPr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u="none" strike="noStrike" dirty="0"/>
                        <a:t>abcg4b</a:t>
                      </a:r>
                      <a:endParaRPr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AATCGTTCGGAGCTGGAGTG</a:t>
                      </a:r>
                      <a:endParaRPr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GCATCCTCCACGTCCAGTAG </a:t>
                      </a:r>
                      <a:endParaRPr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u="none" strike="noStrike" dirty="0"/>
                        <a:t>XM_021619008.1</a:t>
                      </a:r>
                      <a:endParaRPr dirty="0"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00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 u="none" noProof="0" dirty="0">
                          <a:solidFill>
                            <a:schemeClr val="tx1"/>
                          </a:solidFill>
                          <a:latin typeface="+mn-lt"/>
                          <a:ea typeface="Arial MT"/>
                          <a:cs typeface="Arial MT"/>
                        </a:rPr>
                        <a:t>Pro-inflammatory cytokines and chemokines receptors</a:t>
                      </a: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fr-FR" sz="1100" i="1" dirty="0"/>
                        <a:t>il1b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ACGGTTCGCTTCCTCTTCTACA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CTCCAGTGAGGTGCTGATGAA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AJ245925.2</a:t>
                      </a:r>
                      <a:endParaRPr dirty="0"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5850751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fr-FR" sz="1100" i="1" dirty="0"/>
                        <a:t>il8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TCAGCCAGCCTTGTCGTTGT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CGTCTGCTTTCCGTCTCAATGC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NM_001124362.1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5415637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fr-FR" sz="1100" i="1" dirty="0"/>
                        <a:t>tnfa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GCGAGCATACCACTCCTCTGA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AGCTGGAACACTGCACCAAGGT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NM_001124362.1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7121966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fr-FR" sz="1100" i="1" dirty="0"/>
                        <a:t>cxcr4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TCAAGAGTTCTGCTCGCCG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TCTGACTCTGTCGTTGTGGAC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</a:rPr>
                        <a:t>XM_021594980.2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81938398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fr-FR" sz="1100" i="1" dirty="0"/>
                        <a:t>cxcr4.1.1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TTCCGTTTCCAGCACATTCT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ATGATGCAGTAGCAGGTGAGG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</a:rPr>
                        <a:t>NM_001124342.2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21881376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en-US" sz="1100" u="none" baseline="0" dirty="0">
                          <a:solidFill>
                            <a:schemeClr val="tx1"/>
                          </a:solidFill>
                          <a:latin typeface="+mn-lt"/>
                          <a:ea typeface="Arial MT"/>
                          <a:cs typeface="Arial MT"/>
                        </a:rPr>
                        <a:t>Tight junction proteins</a:t>
                      </a: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fr-FR" sz="1100" i="1" dirty="0"/>
                        <a:t>tjp1a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dirty="0"/>
                        <a:t>TCAGCTGCGCTATGATGAGG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100" dirty="0"/>
                        <a:t>GGTCGTAACGTAGAGGAGCG</a:t>
                      </a:r>
                      <a:endParaRPr sz="11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XM_036980662.1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35260039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fr-FR" sz="1100" i="1" dirty="0"/>
                        <a:t>tjp3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GGACACAGCCGTGATAGTT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TGACACGCCATTGACCATGA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</a:rPr>
                        <a:t>XM_031822609.1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24853508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fr-FR" sz="1100" i="1" dirty="0"/>
                        <a:t>marveld1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GTGATCGGCGTCATGATCT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TGGCAGCCAGGTAGACTTT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fr-FR" sz="1200" b="0" u="non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XM_021576418.2</a:t>
                      </a:r>
                      <a:endParaRPr sz="1200" u="none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21615851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fr-FR" sz="1100" i="1" dirty="0"/>
                        <a:t>marveld3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TTCCACCAGCTCAAGCTACC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GGACTCTCAAAACCCCGAA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fr-FR" sz="1200" dirty="0">
                          <a:solidFill>
                            <a:schemeClr val="tx1"/>
                          </a:solidFill>
                        </a:rPr>
                        <a:t>XM_021586195.2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7074077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r>
                        <a:rPr lang="fr-FR" sz="1100" u="none" dirty="0" err="1">
                          <a:solidFill>
                            <a:schemeClr val="tx1"/>
                          </a:solidFill>
                          <a:latin typeface="+mn-lt"/>
                          <a:ea typeface="Arial MT"/>
                          <a:cs typeface="Arial MT"/>
                        </a:rPr>
                        <a:t>FFARs</a:t>
                      </a: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sz="1100" i="1" dirty="0"/>
                        <a:t>ffar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ACT GTT GCA CCT GAG TCT GG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CT GGT CCT GGG TGA AGT TC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ENSOMYG00000041396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21107681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pt-BR" sz="1100" i="1" dirty="0"/>
                        <a:t>ffar2a1a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CCG AGT TCC TCT GCT CCA TC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TAG GTG ATG GGG AAG GCA AC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ENSOMYG00000004986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29094224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pt-BR" sz="1100" i="1" dirty="0"/>
                        <a:t>ffar2a2</a:t>
                      </a:r>
                    </a:p>
                    <a:p>
                      <a:pPr algn="ctr">
                        <a:defRPr/>
                      </a:pP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AC AAC TTC ACC CAG GAG CA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AGC AGA ACA CAC AGG CCA G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ENSOMYG00000030315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38037055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1100" i="1" dirty="0"/>
                        <a:t>ffar2b1.1</a:t>
                      </a:r>
                    </a:p>
                    <a:p>
                      <a:pPr algn="ctr">
                        <a:defRPr/>
                      </a:pP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TTT TCC ACA CAC AGT TGG CC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AGG TAG TGT </a:t>
                      </a:r>
                      <a:r>
                        <a:rPr lang="en-US" sz="1200" dirty="0" err="1"/>
                        <a:t>TGT</a:t>
                      </a:r>
                      <a:r>
                        <a:rPr lang="en-US" sz="1200" dirty="0"/>
                        <a:t> CGG CAT CT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ENSOMYG00000041393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42059802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pt-BR" sz="1100" i="1" dirty="0"/>
                        <a:t>ffar2b1.2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nl-NL" sz="1200" dirty="0"/>
                        <a:t>GTG TGG CCT TCC CTA TCA GA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CA GGG CAC AAT GTA CAC AA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ENSOMYG00000041387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11252448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pt-BR" sz="1100" i="1" dirty="0"/>
                        <a:t>ffar2b2a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CCC ATC CAA CAC TCG CTG AA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TGA </a:t>
                      </a:r>
                      <a:r>
                        <a:rPr lang="en-US" sz="1200" dirty="0" err="1"/>
                        <a:t>TGA</a:t>
                      </a:r>
                      <a:r>
                        <a:rPr lang="en-US" sz="1200" dirty="0"/>
                        <a:t> CGA </a:t>
                      </a:r>
                      <a:r>
                        <a:rPr lang="en-US" sz="1200" dirty="0" err="1"/>
                        <a:t>CGA</a:t>
                      </a:r>
                      <a:r>
                        <a:rPr lang="en-US" sz="1200" dirty="0"/>
                        <a:t> TGC TCA GG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ENSOMYG00000030493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25267873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pt-BR" sz="1100" i="1" dirty="0"/>
                        <a:t>ffar2b2b1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TGA CCG CAA TCA GTG TCG AA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CCC AGA </a:t>
                      </a:r>
                      <a:r>
                        <a:rPr lang="en-US" sz="1200" dirty="0" err="1"/>
                        <a:t>AGA</a:t>
                      </a:r>
                      <a:r>
                        <a:rPr lang="en-US" sz="1200" dirty="0"/>
                        <a:t> </a:t>
                      </a:r>
                      <a:r>
                        <a:rPr lang="en-US" sz="1200" dirty="0" err="1"/>
                        <a:t>AGA</a:t>
                      </a:r>
                      <a:r>
                        <a:rPr lang="en-US" sz="1200" dirty="0"/>
                        <a:t> CGC TAG CC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ENSOMYG00000030500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33001257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  <a:defRPr/>
                      </a:pPr>
                      <a:endParaRPr lang="en-US" sz="1100" u="none" dirty="0">
                        <a:solidFill>
                          <a:schemeClr val="tx1"/>
                        </a:solidFill>
                        <a:latin typeface="+mn-lt"/>
                        <a:ea typeface="Arial MT"/>
                        <a:cs typeface="Arial MT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pt-BR" sz="1100" i="1" dirty="0"/>
                        <a:t>ffar2b2b2</a:t>
                      </a:r>
                      <a:endParaRPr sz="1100" i="1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GTC CAG TAC CAT CAA CGC CA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/>
                        <a:t>CTG CAC ACT CTC CAA CAG GGT</a:t>
                      </a:r>
                      <a:endParaRPr sz="1200" dirty="0"/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l"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ENSOMYG00000005604</a:t>
                      </a:r>
                      <a:endParaRPr sz="1200" dirty="0">
                        <a:solidFill>
                          <a:schemeClr val="tx1"/>
                        </a:solidFill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xmlns="" val="36564389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GB" sz="1100" dirty="0"/>
                        <a:t>House-keeping genes</a:t>
                      </a:r>
                      <a:endParaRPr lang="en-US" sz="1100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fr-FR" sz="1100" i="1" u="none" strike="noStrike" dirty="0"/>
                        <a:t>eef1a</a:t>
                      </a:r>
                      <a:endParaRPr lang="en-US" sz="1100" b="0" i="1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GB" sz="1100" dirty="0"/>
                        <a:t>TCCTCTTGGTCGTTTCGCTG</a:t>
                      </a:r>
                      <a:endParaRPr lang="en-US" sz="1100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GB" sz="1100" dirty="0"/>
                        <a:t>ACCCGAGGGACATCCTGTG</a:t>
                      </a:r>
                      <a:endParaRPr lang="en-US" sz="1100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GB" sz="1100" dirty="0"/>
                        <a:t>XM_021567853.1</a:t>
                      </a:r>
                      <a:endParaRPr lang="en-US" sz="1100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100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defRPr/>
                      </a:pPr>
                      <a:endParaRPr lang="en-US" sz="1100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GB" sz="1100" i="1" dirty="0"/>
                        <a:t>b actin</a:t>
                      </a:r>
                      <a:endParaRPr lang="en-US" sz="1100" b="0" i="1" u="none" strike="noStrike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latin typeface="+mn-lt"/>
                          <a:ea typeface="Times New Roman"/>
                          <a:cs typeface="Times New Roman"/>
                        </a:rPr>
                        <a:t>GATGGGCCAGAAAGACAGCTA</a:t>
                      </a: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latin typeface="+mn-lt"/>
                          <a:ea typeface="Times New Roman"/>
                          <a:cs typeface="Times New Roman"/>
                        </a:rPr>
                        <a:t>TCGTCCCAGTTGGTGACGAT</a:t>
                      </a: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fr-FR" sz="1100" dirty="0">
                          <a:latin typeface="+mn-lt"/>
                          <a:ea typeface="Times New Roman"/>
                          <a:cs typeface="Times New Roman"/>
                        </a:rPr>
                        <a:t>-</a:t>
                      </a:r>
                      <a:endParaRPr lang="en-US" sz="1100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61"/>
                  </a:ext>
                </a:extLst>
              </a:tr>
            </a:tbl>
          </a:graphicData>
        </a:graphic>
      </p:graphicFrame>
      <p:sp>
        <p:nvSpPr>
          <p:cNvPr id="5" name="ZoneTexte 5">
            <a:extLst>
              <a:ext uri="{FF2B5EF4-FFF2-40B4-BE49-F238E27FC236}">
                <a16:creationId xmlns:a16="http://schemas.microsoft.com/office/drawing/2014/main" xmlns="" id="{5A806325-5A70-4A17-935E-83821F8BD0AA}"/>
              </a:ext>
            </a:extLst>
          </p:cNvPr>
          <p:cNvSpPr txBox="1"/>
          <p:nvPr/>
        </p:nvSpPr>
        <p:spPr>
          <a:xfrm>
            <a:off x="1140333" y="176687"/>
            <a:ext cx="59440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dditional file 3. Table S3 : </a:t>
            </a:r>
            <a:r>
              <a:rPr lang="en-US" sz="1200" dirty="0"/>
              <a:t>Primer sequences and used for RT-qPCR analysis. </a:t>
            </a:r>
          </a:p>
        </p:txBody>
      </p:sp>
    </p:spTree>
    <p:extLst>
      <p:ext uri="{BB962C8B-B14F-4D97-AF65-F5344CB8AC3E}">
        <p14:creationId xmlns:p14="http://schemas.microsoft.com/office/powerpoint/2010/main" val="4219264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40</Words>
  <Application>Microsoft Office PowerPoint</Application>
  <PresentationFormat>On-screen Show (4:3)</PresentationFormat>
  <Paragraphs>29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eta Decipolo</dc:creator>
  <cp:lastModifiedBy>Antonieta Decipolo</cp:lastModifiedBy>
  <cp:revision>1</cp:revision>
  <dcterms:created xsi:type="dcterms:W3CDTF">2023-10-23T00:05:00Z</dcterms:created>
  <dcterms:modified xsi:type="dcterms:W3CDTF">2023-10-23T00:06:33Z</dcterms:modified>
</cp:coreProperties>
</file>